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8" r:id="rId3"/>
    <p:sldId id="27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961204-933F-4AE7-854C-5266ACBD14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F9AFABE-6E05-40AF-AFEB-88AFE8D420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904EB29-7B9F-4226-9B85-54BCEBB39E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5D6D-A77B-4638-A850-27B0E15A7115}" type="datetimeFigureOut">
              <a:rPr lang="zh-CN" altLang="en-US" smtClean="0"/>
              <a:t>2022/4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6A25E10-C3D3-4273-9ADA-E80ED54E6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884205-4D67-46F9-9AA4-D5F38E2436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D302E-0890-49C7-B9FE-A9C0BC9A9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3916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C36148-8D5D-4FE5-A84C-6B84273E07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D082DC2-4EE6-4F3E-857E-D3F3080FEB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33017DD-F7E0-4F33-B3F3-0B58A9BD7C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5D6D-A77B-4638-A850-27B0E15A7115}" type="datetimeFigureOut">
              <a:rPr lang="zh-CN" altLang="en-US" smtClean="0"/>
              <a:t>2022/4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869D34-EF32-4951-AD4F-25F137B32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3E5D89-0321-4608-9D4C-3F19479F1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D302E-0890-49C7-B9FE-A9C0BC9A9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1249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7AE90A5-E59D-43D2-8801-256842BCCC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29075BC-3CAD-4676-AAF9-302E32D4F2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01ACA2-2D6C-4415-A33C-0C487FA59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5D6D-A77B-4638-A850-27B0E15A7115}" type="datetimeFigureOut">
              <a:rPr lang="zh-CN" altLang="en-US" smtClean="0"/>
              <a:t>2022/4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5B5725B-0D87-43FE-945B-79674574B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D92B1D4-8FDC-4E71-B899-5359DF82BC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D302E-0890-49C7-B9FE-A9C0BC9A9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7324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26C3FD-B381-46A2-9C99-169D95A8DD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744C55B-F85C-4755-9B3B-A875EE1372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05869D-1865-4C5C-B139-5900B6165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5D6D-A77B-4638-A850-27B0E15A7115}" type="datetimeFigureOut">
              <a:rPr lang="zh-CN" altLang="en-US" smtClean="0"/>
              <a:t>2022/4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DEDF56-689A-4CC5-8C3F-204BC0F64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230111-77B9-4FAB-A9EB-6DC37D4FAD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D302E-0890-49C7-B9FE-A9C0BC9A9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0165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703CCF-EB39-46C2-AD6C-1439D2B606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7F75B0F-F48A-42AD-AAF3-468773AC84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A3B539-4B00-4488-9E85-F69D66650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5D6D-A77B-4638-A850-27B0E15A7115}" type="datetimeFigureOut">
              <a:rPr lang="zh-CN" altLang="en-US" smtClean="0"/>
              <a:t>2022/4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8CDB7B5-5EBA-44A9-B11E-A26A876E9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E23FF99-973B-4C9C-A17B-77F471F06B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D302E-0890-49C7-B9FE-A9C0BC9A9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6883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2468F2-FE02-488D-B4AD-5E003B5E40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2DA95B4-118B-4D61-A63E-65DD245B5E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F02FC2E-0EDE-41A1-B3D6-F2FD1210FB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C6A3513-6799-4F3C-B634-CACC4B6F3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5D6D-A77B-4638-A850-27B0E15A7115}" type="datetimeFigureOut">
              <a:rPr lang="zh-CN" altLang="en-US" smtClean="0"/>
              <a:t>2022/4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6FC9C54-A562-47EC-9870-92D6302147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3BB5D3E-69A8-4F3D-BE38-F169CAEBD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D302E-0890-49C7-B9FE-A9C0BC9A9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8887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6A06A5-A359-4509-BCDE-B774E847D4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33BBA00-EE32-4774-BF33-C82F1F4AEB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AAA1DEF-27A2-4B40-8705-EEDCE66AE8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BC32848-69EF-4D4F-9DBD-9BE2614A29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44CEF92-8C2E-4C32-BA19-7F1DF6F19C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A96E920-4DEE-422E-81FD-C128EC497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5D6D-A77B-4638-A850-27B0E15A7115}" type="datetimeFigureOut">
              <a:rPr lang="zh-CN" altLang="en-US" smtClean="0"/>
              <a:t>2022/4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6DFEBC2-5E91-4810-82FE-2B12B2834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C8D77E0-F140-411E-BEA3-59F0AB0C14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D302E-0890-49C7-B9FE-A9C0BC9A9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2303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97954E-3970-437B-839F-96CFEC5796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A711229-D222-4E37-A201-5F65C58A1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5D6D-A77B-4638-A850-27B0E15A7115}" type="datetimeFigureOut">
              <a:rPr lang="zh-CN" altLang="en-US" smtClean="0"/>
              <a:t>2022/4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074F862-CF6F-400A-8A79-AEFFAA475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D2FE382-E71B-40B9-92AB-5157DC7B6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D302E-0890-49C7-B9FE-A9C0BC9A9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130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8C9F91A-B764-4AAD-99DD-5F26F49F7B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5D6D-A77B-4638-A850-27B0E15A7115}" type="datetimeFigureOut">
              <a:rPr lang="zh-CN" altLang="en-US" smtClean="0"/>
              <a:t>2022/4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77382B1-9F78-4817-A5B4-7B565B505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5183D88-4434-4C50-B900-3EE10E175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D302E-0890-49C7-B9FE-A9C0BC9A9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5468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7BA47A-B148-472E-9ACA-F00E099F3B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2CF2F6A-8CD8-4E3D-91A5-62C4369066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1260A4A-4CF3-4CE7-82F9-D4F4FAFA44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33038D6-85E9-4C92-B901-F0479A7CD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5D6D-A77B-4638-A850-27B0E15A7115}" type="datetimeFigureOut">
              <a:rPr lang="zh-CN" altLang="en-US" smtClean="0"/>
              <a:t>2022/4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E76EB7D-15EF-4C0B-82A8-799E273E0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B5CE0A5-FC5F-4842-8B9C-D2DF3E2F5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D302E-0890-49C7-B9FE-A9C0BC9A9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7593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8C857E-EA67-4B3C-830F-C61BF3E8D4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F0D59C7-FD15-4C9E-8D1A-59D1412F2F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17A59C7-336D-4159-90BC-0D2A2299B4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3650FF6-97A5-448E-9207-13402F104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5D6D-A77B-4638-A850-27B0E15A7115}" type="datetimeFigureOut">
              <a:rPr lang="zh-CN" altLang="en-US" smtClean="0"/>
              <a:t>2022/4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A95A2C0-D48F-4C87-9210-F0D819EF7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47EB040-8A23-4329-B8F4-992F4F8CB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D302E-0890-49C7-B9FE-A9C0BC9A9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05563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3513300-7F86-42AD-8B9B-10F38AED1D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FB3E1EB-EAE7-42BC-83AA-91C9068231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5B0476-2E32-4CC9-A333-300BF34DCB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C5D6D-A77B-4638-A850-27B0E15A7115}" type="datetimeFigureOut">
              <a:rPr lang="zh-CN" altLang="en-US" smtClean="0"/>
              <a:t>2022/4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90FED8-404A-426E-8886-4ADB62DCD0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462F17-6A0E-47BD-A233-FF164995C9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AD302E-0890-49C7-B9FE-A9C0BC9A9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4601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wmf"/><Relationship Id="rId13" Type="http://schemas.openxmlformats.org/officeDocument/2006/relationships/image" Target="../media/image15.wmf"/><Relationship Id="rId3" Type="http://schemas.openxmlformats.org/officeDocument/2006/relationships/image" Target="../media/image5.wmf"/><Relationship Id="rId7" Type="http://schemas.openxmlformats.org/officeDocument/2006/relationships/image" Target="../media/image9.wmf"/><Relationship Id="rId12" Type="http://schemas.openxmlformats.org/officeDocument/2006/relationships/image" Target="../media/image14.wmf"/><Relationship Id="rId2" Type="http://schemas.openxmlformats.org/officeDocument/2006/relationships/image" Target="../media/image4.wmf"/><Relationship Id="rId16" Type="http://schemas.openxmlformats.org/officeDocument/2006/relationships/image" Target="../media/image18.w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wmf"/><Relationship Id="rId11" Type="http://schemas.openxmlformats.org/officeDocument/2006/relationships/image" Target="../media/image13.wmf"/><Relationship Id="rId5" Type="http://schemas.openxmlformats.org/officeDocument/2006/relationships/image" Target="../media/image7.wmf"/><Relationship Id="rId15" Type="http://schemas.openxmlformats.org/officeDocument/2006/relationships/image" Target="../media/image17.wmf"/><Relationship Id="rId10" Type="http://schemas.openxmlformats.org/officeDocument/2006/relationships/image" Target="../media/image12.wmf"/><Relationship Id="rId4" Type="http://schemas.openxmlformats.org/officeDocument/2006/relationships/image" Target="../media/image6.wmf"/><Relationship Id="rId9" Type="http://schemas.openxmlformats.org/officeDocument/2006/relationships/image" Target="../media/image11.wmf"/><Relationship Id="rId14" Type="http://schemas.openxmlformats.org/officeDocument/2006/relationships/image" Target="../media/image1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A771A14D-E649-4976-AF6D-207A2D1CA3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5872" y="-22830"/>
            <a:ext cx="3192156" cy="68580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5FC3EDBD-0024-446C-88A4-849E97EF7B4A}"/>
              </a:ext>
            </a:extLst>
          </p:cNvPr>
          <p:cNvSpPr txBox="1"/>
          <p:nvPr/>
        </p:nvSpPr>
        <p:spPr>
          <a:xfrm>
            <a:off x="8824404" y="2974019"/>
            <a:ext cx="165124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1 </a:t>
            </a:r>
            <a:r>
              <a:rPr lang="en-US" altLang="zh-CN" dirty="0" err="1"/>
              <a:t>Kegg</a:t>
            </a:r>
            <a:r>
              <a:rPr lang="en-US" altLang="zh-CN" dirty="0"/>
              <a:t> analysis of co-DEGs relative to red pigment formatio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83901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A601337-F3A3-4535-917C-189D976610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1436" y="858123"/>
            <a:ext cx="3747400" cy="471848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CEF3E3B7-0E3D-4ECF-839B-8D35F54D6556}"/>
              </a:ext>
            </a:extLst>
          </p:cNvPr>
          <p:cNvSpPr txBox="1"/>
          <p:nvPr/>
        </p:nvSpPr>
        <p:spPr>
          <a:xfrm>
            <a:off x="3430127" y="5692099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HLH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BEA23166-D467-4DDE-B1C1-44FA7934FE4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4520" y="858124"/>
            <a:ext cx="2922514" cy="4653208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37AF7763-6617-4D7B-A03B-F9EDDA30F80D}"/>
              </a:ext>
            </a:extLst>
          </p:cNvPr>
          <p:cNvSpPr txBox="1"/>
          <p:nvPr/>
        </p:nvSpPr>
        <p:spPr>
          <a:xfrm>
            <a:off x="7431391" y="5692099"/>
            <a:ext cx="595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BEA9458-BD95-48AB-8F24-4BC894869603}"/>
              </a:ext>
            </a:extLst>
          </p:cNvPr>
          <p:cNvSpPr txBox="1"/>
          <p:nvPr/>
        </p:nvSpPr>
        <p:spPr>
          <a:xfrm>
            <a:off x="9360926" y="3225479"/>
            <a:ext cx="252072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Figure S2 Heatmap of </a:t>
            </a:r>
            <a:r>
              <a:rPr lang="en-US" altLang="zh-CN" sz="1400" dirty="0" err="1"/>
              <a:t>bHLH</a:t>
            </a:r>
            <a:r>
              <a:rPr lang="en-US" altLang="zh-CN" sz="1400" dirty="0"/>
              <a:t> and MYB transcription factors among co-DEGs relative to red pigment formation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1331932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图片 34" descr="Project Path: C:\Users\77487\Desktop\油菜花色\花瓣图片和色素\草稿\附图\QPCR验证ANS-4.opju&#10;PE Folder: /QPCR验证ANS-4/Folder1/&#10;Short Name: Graph2">
            <a:extLst>
              <a:ext uri="{FF2B5EF4-FFF2-40B4-BE49-F238E27FC236}">
                <a16:creationId xmlns:a16="http://schemas.microsoft.com/office/drawing/2014/main" id="{7FC225F4-8E63-4D7D-B758-3AF783CF45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7552" y="183355"/>
            <a:ext cx="2611765" cy="2160000"/>
          </a:xfrm>
          <a:prstGeom prst="rect">
            <a:avLst/>
          </a:prstGeom>
        </p:spPr>
      </p:pic>
      <p:pic>
        <p:nvPicPr>
          <p:cNvPr id="36" name="图片 35" descr="Project Path: C:\Users\77487\Desktop\油菜花色\花瓣图片和色素\草稿\附图\QPCR验证ANS-4.opju&#10;PE Folder: /QPCR验证ANS-4/Folder1/&#10;Short Name: Graph3">
            <a:extLst>
              <a:ext uri="{FF2B5EF4-FFF2-40B4-BE49-F238E27FC236}">
                <a16:creationId xmlns:a16="http://schemas.microsoft.com/office/drawing/2014/main" id="{FAFE153F-D028-4016-AB45-768EDA93F0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13376" y="183355"/>
            <a:ext cx="2640000" cy="2160000"/>
          </a:xfrm>
          <a:prstGeom prst="rect">
            <a:avLst/>
          </a:prstGeom>
        </p:spPr>
      </p:pic>
      <p:pic>
        <p:nvPicPr>
          <p:cNvPr id="37" name="图片 36" descr="Project Path: C:\Users\77487\Desktop\油菜花色\花瓣图片和色素\草稿\附图\QPCR验证ANS-4.opju&#10;PE Folder: /QPCR验证ANS-4/Folder1/&#10;Short Name: Graph4">
            <a:extLst>
              <a:ext uri="{FF2B5EF4-FFF2-40B4-BE49-F238E27FC236}">
                <a16:creationId xmlns:a16="http://schemas.microsoft.com/office/drawing/2014/main" id="{74C68948-EA54-4C40-92F6-74011FD6A58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30122" y="183355"/>
            <a:ext cx="2611765" cy="2160000"/>
          </a:xfrm>
          <a:prstGeom prst="rect">
            <a:avLst/>
          </a:prstGeom>
        </p:spPr>
      </p:pic>
      <p:pic>
        <p:nvPicPr>
          <p:cNvPr id="38" name="图片 37" descr="Project Path: C:\Users\77487\Desktop\油菜花色\花瓣图片和色素\草稿\附图\QPCR验证ANS-4.opju&#10;PE Folder: /QPCR验证ANS-4/Folder1/&#10;Short Name: Graph6">
            <a:extLst>
              <a:ext uri="{FF2B5EF4-FFF2-40B4-BE49-F238E27FC236}">
                <a16:creationId xmlns:a16="http://schemas.microsoft.com/office/drawing/2014/main" id="{4A0284A3-8674-41D8-875A-F1F598F33C5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67294" y="183355"/>
            <a:ext cx="2724706" cy="2160000"/>
          </a:xfrm>
          <a:prstGeom prst="rect">
            <a:avLst/>
          </a:prstGeom>
        </p:spPr>
      </p:pic>
      <p:pic>
        <p:nvPicPr>
          <p:cNvPr id="39" name="图片 1" descr="Project Path: C:\Users\77487\Desktop\油菜花色\花瓣图片和色素\草稿\附图\QPCR验证ANS-4.opju&#10;PE Folder: /QPCR验证ANS-4/Folder1/&#10;Short Name: Graph1">
            <a:extLst>
              <a:ext uri="{FF2B5EF4-FFF2-40B4-BE49-F238E27FC236}">
                <a16:creationId xmlns:a16="http://schemas.microsoft.com/office/drawing/2014/main" id="{A3777A5E-B07F-4152-A4F6-82478BDB5C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60" y="183355"/>
            <a:ext cx="2773000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2D978E6A-9ED7-4C37-B1F7-8DFDC71F2FAC}"/>
              </a:ext>
            </a:extLst>
          </p:cNvPr>
          <p:cNvSpPr txBox="1"/>
          <p:nvPr/>
        </p:nvSpPr>
        <p:spPr>
          <a:xfrm>
            <a:off x="1193906" y="183355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S4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A9453614-6381-4D00-A180-DC38C1D45F6A}"/>
              </a:ext>
            </a:extLst>
          </p:cNvPr>
          <p:cNvSpPr txBox="1"/>
          <p:nvPr/>
        </p:nvSpPr>
        <p:spPr>
          <a:xfrm>
            <a:off x="3700566" y="183354"/>
            <a:ext cx="5245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S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4985124E-AE2A-4671-AAD5-BE9661865532}"/>
              </a:ext>
            </a:extLst>
          </p:cNvPr>
          <p:cNvSpPr txBox="1"/>
          <p:nvPr/>
        </p:nvSpPr>
        <p:spPr>
          <a:xfrm>
            <a:off x="6125848" y="177335"/>
            <a:ext cx="4940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D9D44CEA-E3E6-49B2-B1BB-6F26CBDBD4F0}"/>
              </a:ext>
            </a:extLst>
          </p:cNvPr>
          <p:cNvSpPr txBox="1"/>
          <p:nvPr/>
        </p:nvSpPr>
        <p:spPr>
          <a:xfrm>
            <a:off x="8267059" y="177335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3H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088CBA62-64F8-4954-855D-E8D5CB14BCE8}"/>
              </a:ext>
            </a:extLst>
          </p:cNvPr>
          <p:cNvSpPr txBox="1"/>
          <p:nvPr/>
        </p:nvSpPr>
        <p:spPr>
          <a:xfrm>
            <a:off x="10503115" y="177335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S2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5" name="图片 1" descr="Project Path: C:\Users\77487\Desktop\油菜花色\花瓣图片和色素\草稿\附图\QPCR验证ANS-4.opju&#10;PE Folder: /QPCR验证ANS-4/Folder1/&#10;Short Name: Graph7">
            <a:extLst>
              <a:ext uri="{FF2B5EF4-FFF2-40B4-BE49-F238E27FC236}">
                <a16:creationId xmlns:a16="http://schemas.microsoft.com/office/drawing/2014/main" id="{2A42188E-7AAE-4F9B-9911-ECD64DCFB0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60" y="4514646"/>
            <a:ext cx="2781000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6" name="图片 1" descr="Project Path: C:\Users\77487\Desktop\油菜花色\花瓣图片和色素\草稿\附图\QPCR验证ANS-4.opju&#10;PE Folder: /QPCR验证ANS-4/Folder1/&#10;Short Name: Graph6">
            <a:extLst>
              <a:ext uri="{FF2B5EF4-FFF2-40B4-BE49-F238E27FC236}">
                <a16:creationId xmlns:a16="http://schemas.microsoft.com/office/drawing/2014/main" id="{D1406E80-3D67-4711-88F6-CFD2F111425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2531" y="4514646"/>
            <a:ext cx="2724500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7" name="图片 1" descr="Project Path: C:\Users\77487\Desktop\油菜花色\花瓣图片和色素\草稿\附图\QPCR验证ANS-4.opju&#10;PE Folder: /QPCR验证ANS-4/Folder1/&#10;Short Name: Graph4">
            <a:extLst>
              <a:ext uri="{FF2B5EF4-FFF2-40B4-BE49-F238E27FC236}">
                <a16:creationId xmlns:a16="http://schemas.microsoft.com/office/drawing/2014/main" id="{1E2E86B6-C2B0-412A-A2A5-6EA1DFA2DB7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5764" y="4514646"/>
            <a:ext cx="2612000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8" name="图片 1" descr="Project Path: C:\Users\77487\Desktop\油菜花色\花瓣图片和色素\草稿\附图\QPCR验证ANS-4.opju&#10;PE Folder: /QPCR验证ANS-4/Folder1/&#10;Short Name: Graph5">
            <a:extLst>
              <a:ext uri="{FF2B5EF4-FFF2-40B4-BE49-F238E27FC236}">
                <a16:creationId xmlns:a16="http://schemas.microsoft.com/office/drawing/2014/main" id="{E69035DF-E4C8-4CEA-BEC5-C07AAFC253C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36453" y="4514646"/>
            <a:ext cx="2640000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9" name="图片 1" descr="Project Path: C:\Users\77487\Desktop\油菜花色\花瓣图片和色素\草稿\附图\QPCR验证ANS-4.opju&#10;PE Folder: /QPCR验证ANS-4/Folder1/&#10;Short Name: Graph2">
            <a:extLst>
              <a:ext uri="{FF2B5EF4-FFF2-40B4-BE49-F238E27FC236}">
                <a16:creationId xmlns:a16="http://schemas.microsoft.com/office/drawing/2014/main" id="{6939694E-9354-40AF-A77C-9E765AE62CB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26890" y="4514646"/>
            <a:ext cx="2668000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0" name="文本框 49">
            <a:extLst>
              <a:ext uri="{FF2B5EF4-FFF2-40B4-BE49-F238E27FC236}">
                <a16:creationId xmlns:a16="http://schemas.microsoft.com/office/drawing/2014/main" id="{F0D991A5-06E7-4121-926D-9DE73B43E577}"/>
              </a:ext>
            </a:extLst>
          </p:cNvPr>
          <p:cNvSpPr txBox="1"/>
          <p:nvPr/>
        </p:nvSpPr>
        <p:spPr>
          <a:xfrm>
            <a:off x="1103126" y="4585667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F3GT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177717AC-4AC2-48FC-99D9-F3E6ACB5BB41}"/>
              </a:ext>
            </a:extLst>
          </p:cNvPr>
          <p:cNvSpPr txBox="1"/>
          <p:nvPr/>
        </p:nvSpPr>
        <p:spPr>
          <a:xfrm>
            <a:off x="3688129" y="4581575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5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A9FB674-9DA1-4EEE-8BB1-3B7AD9A00DF1}"/>
              </a:ext>
            </a:extLst>
          </p:cNvPr>
          <p:cNvSpPr txBox="1"/>
          <p:nvPr/>
        </p:nvSpPr>
        <p:spPr>
          <a:xfrm>
            <a:off x="10578020" y="4585666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C1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BD32194A-82B3-4DF7-B940-D4A60620B807}"/>
              </a:ext>
            </a:extLst>
          </p:cNvPr>
          <p:cNvSpPr txBox="1"/>
          <p:nvPr/>
        </p:nvSpPr>
        <p:spPr>
          <a:xfrm>
            <a:off x="5955557" y="4585665"/>
            <a:ext cx="7847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111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14345861-FB81-4998-AE34-5804B53FE430}"/>
              </a:ext>
            </a:extLst>
          </p:cNvPr>
          <p:cNvSpPr txBox="1"/>
          <p:nvPr/>
        </p:nvSpPr>
        <p:spPr>
          <a:xfrm>
            <a:off x="8231631" y="4585665"/>
            <a:ext cx="7216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61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5" name="图片 1" descr="Project Path: C:\Users\77487\Desktop\油菜花色\花瓣图片和色素\草稿\附图\QPCR验证ANS-4.opju&#10;PE Folder: /QPCR验证ANS-4/Folder1/&#10;Short Name: Graph7">
            <a:extLst>
              <a:ext uri="{FF2B5EF4-FFF2-40B4-BE49-F238E27FC236}">
                <a16:creationId xmlns:a16="http://schemas.microsoft.com/office/drawing/2014/main" id="{F886B380-E2F3-4FED-936B-F101FEE222A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4817" y="2326816"/>
            <a:ext cx="2724500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6" name="图片 1" descr="Project Path: C:\Users\77487\Desktop\油菜花色\花瓣图片和色素\草稿\附图\QPCR验证ANS-4.opju&#10;PE Folder: /QPCR验证ANS-4/Folder1/&#10;Short Name: Graph6">
            <a:extLst>
              <a:ext uri="{FF2B5EF4-FFF2-40B4-BE49-F238E27FC236}">
                <a16:creationId xmlns:a16="http://schemas.microsoft.com/office/drawing/2014/main" id="{EC0961AA-6B33-4532-B50D-DF46ACF079B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646" y="2326815"/>
            <a:ext cx="2668000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7" name="图片 1" descr="Project Path: C:\Users\77487\Desktop\油菜花色\花瓣图片和色素\草稿\附图\QPCR验证ANS-4.opju&#10;PE Folder: /QPCR验证ANS-4/Folder1/&#10;Short Name: Graph5">
            <a:extLst>
              <a:ext uri="{FF2B5EF4-FFF2-40B4-BE49-F238E27FC236}">
                <a16:creationId xmlns:a16="http://schemas.microsoft.com/office/drawing/2014/main" id="{4DF52EA4-DE53-4478-A4EE-F231F9ABF7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68599" y="2323541"/>
            <a:ext cx="2781000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8" name="图片 1" descr="Project Path: C:\Users\77487\Desktop\油菜花色\花瓣图片和色素\草稿\附图\QPCR验证ANS-4.opju&#10;PE Folder: /QPCR验证ANS-4/Folder1/&#10;Short Name: Graph4">
            <a:extLst>
              <a:ext uri="{FF2B5EF4-FFF2-40B4-BE49-F238E27FC236}">
                <a16:creationId xmlns:a16="http://schemas.microsoft.com/office/drawing/2014/main" id="{C58989E2-63D2-4932-BCE5-1C69CC84C3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3850" y="2335448"/>
            <a:ext cx="2781000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9" name="图片 1" descr="Project Path: C:\Users\77487\Desktop\油菜花色\花瓣图片和色素\草稿\附图\QPCR验证ANS-4.opju&#10;PE Folder: /QPCR验证ANS-4/Folder1/&#10;Short Name: Graph2">
            <a:extLst>
              <a:ext uri="{FF2B5EF4-FFF2-40B4-BE49-F238E27FC236}">
                <a16:creationId xmlns:a16="http://schemas.microsoft.com/office/drawing/2014/main" id="{4354F253-3609-4638-A98E-DC132BFE647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42837" y="2326816"/>
            <a:ext cx="2668000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0" name="文本框 59">
            <a:extLst>
              <a:ext uri="{FF2B5EF4-FFF2-40B4-BE49-F238E27FC236}">
                <a16:creationId xmlns:a16="http://schemas.microsoft.com/office/drawing/2014/main" id="{83724994-03F2-4146-B5D4-1DCA031D477F}"/>
              </a:ext>
            </a:extLst>
          </p:cNvPr>
          <p:cNvSpPr txBox="1"/>
          <p:nvPr/>
        </p:nvSpPr>
        <p:spPr>
          <a:xfrm>
            <a:off x="10580121" y="2326816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3’H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41E850E7-0AF0-4C8D-92BD-58615F38B285}"/>
              </a:ext>
            </a:extLst>
          </p:cNvPr>
          <p:cNvSpPr txBox="1"/>
          <p:nvPr/>
        </p:nvSpPr>
        <p:spPr>
          <a:xfrm>
            <a:off x="3703791" y="2323541"/>
            <a:ext cx="5783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P2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C113871E-7B25-44EC-9900-820580C90D4D}"/>
              </a:ext>
            </a:extLst>
          </p:cNvPr>
          <p:cNvSpPr txBox="1"/>
          <p:nvPr/>
        </p:nvSpPr>
        <p:spPr>
          <a:xfrm>
            <a:off x="8231857" y="2351987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FR2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5474BB6E-6938-40A8-B9A1-4E6080AB9B0E}"/>
              </a:ext>
            </a:extLst>
          </p:cNvPr>
          <p:cNvSpPr txBox="1"/>
          <p:nvPr/>
        </p:nvSpPr>
        <p:spPr>
          <a:xfrm>
            <a:off x="1134554" y="2326815"/>
            <a:ext cx="5783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P1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3152C40F-D53C-46A0-9ECA-6C56ABBE89F9}"/>
              </a:ext>
            </a:extLst>
          </p:cNvPr>
          <p:cNvSpPr txBox="1"/>
          <p:nvPr/>
        </p:nvSpPr>
        <p:spPr>
          <a:xfrm>
            <a:off x="6082073" y="2351987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FR1</a:t>
            </a:r>
            <a:endParaRPr lang="zh-CN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A6C59C3-5286-4C15-9C9B-AAAE64693B78}"/>
              </a:ext>
            </a:extLst>
          </p:cNvPr>
          <p:cNvSpPr txBox="1"/>
          <p:nvPr/>
        </p:nvSpPr>
        <p:spPr>
          <a:xfrm>
            <a:off x="3817067" y="6479965"/>
            <a:ext cx="50193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Figure S3 </a:t>
            </a:r>
            <a:r>
              <a:rPr lang="en-US" altLang="zh-CN" sz="1400" dirty="0" err="1"/>
              <a:t>qRT</a:t>
            </a:r>
            <a:r>
              <a:rPr lang="en-US" altLang="zh-CN" sz="1400" dirty="0"/>
              <a:t>-PCR identification of gene relative to anthocyanin biosynthesis.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6829191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5</TotalTime>
  <Words>55</Words>
  <Application>Microsoft Office PowerPoint</Application>
  <PresentationFormat>宽屏</PresentationFormat>
  <Paragraphs>20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郝 鹏飞</dc:creator>
  <cp:lastModifiedBy>郝 鹏飞</cp:lastModifiedBy>
  <cp:revision>5</cp:revision>
  <dcterms:created xsi:type="dcterms:W3CDTF">2022-01-26T07:50:25Z</dcterms:created>
  <dcterms:modified xsi:type="dcterms:W3CDTF">2022-04-28T08:10:00Z</dcterms:modified>
</cp:coreProperties>
</file>